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480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3B9E72-4CEF-4898-B536-43708FE34E1E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8B6DBF-F890-49C9-9D72-C19FB91ACA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36602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幻灯片图像占位符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9699" name="备注占位符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r>
              <a:rPr lang="zh-CN" altLang="en-US" smtClean="0"/>
              <a:t>这里也是一样都需要加上 </a:t>
            </a:r>
            <a:r>
              <a:rPr lang="en-US" altLang="zh-CN" smtClean="0"/>
              <a:t>_All </a:t>
            </a:r>
            <a:r>
              <a:rPr lang="zh-CN" altLang="en-US" smtClean="0"/>
              <a:t>的后缀</a:t>
            </a:r>
          </a:p>
        </p:txBody>
      </p:sp>
      <p:sp>
        <p:nvSpPr>
          <p:cNvPr id="29700" name="灯片编号占位符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charset="-122"/>
              </a:defRPr>
            </a:lvl9pPr>
          </a:lstStyle>
          <a:p>
            <a:fld id="{3907C8A5-9C76-45A3-A7F1-2C6363E457B1}" type="slidenum">
              <a:rPr lang="zh-CN" altLang="en-US" smtClean="0"/>
              <a:pPr/>
              <a:t>1</a:t>
            </a:fld>
            <a:endParaRPr lang="zh-CN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2611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8223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932683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A6086C-F872-46A7-93DB-421D870ED879}" type="datetime1">
              <a:rPr lang="zh-CN" altLang="en-US"/>
              <a:pPr>
                <a:defRPr/>
              </a:pPr>
              <a:t>5/28/15</a:t>
            </a:fld>
            <a:endParaRPr lang="zh-CN" altLang="en-US" sz="1800">
              <a:solidFill>
                <a:schemeClr val="tx1"/>
              </a:solidFill>
            </a:endParaRPr>
          </a:p>
        </p:txBody>
      </p:sp>
      <p:sp>
        <p:nvSpPr>
          <p:cNvPr id="4" name="页脚占位符 4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zh-CN"/>
          </a:p>
        </p:txBody>
      </p:sp>
      <p:sp>
        <p:nvSpPr>
          <p:cNvPr id="5" name="灯片编号占位符 5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C70F66-32CC-4DC0-8424-60E398CF9DE8}" type="slidenum">
              <a:rPr lang="zh-CN" altLang="en-US"/>
              <a:pPr>
                <a:defRPr/>
              </a:pPr>
              <a:t>‹#›</a:t>
            </a:fld>
            <a:endParaRPr lang="zh-CN" altLang="en-US" sz="180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61128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488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833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2951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2233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59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86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2090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1806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F1367C-F449-464D-8103-8D6B5579412D}" type="datetimeFigureOut">
              <a:rPr lang="zh-CN" altLang="en-US" smtClean="0"/>
              <a:t>5/28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1589FC-D7CD-4D9A-890F-D0DBE99203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0061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539750" y="1268413"/>
          <a:ext cx="7993063" cy="4568820"/>
        </p:xfrm>
        <a:graphic>
          <a:graphicData uri="http://schemas.openxmlformats.org/drawingml/2006/table">
            <a:tbl>
              <a:tblPr firstRow="1" firstCol="1" bandRow="1"/>
              <a:tblGrid>
                <a:gridCol w="3105469"/>
                <a:gridCol w="1373789"/>
                <a:gridCol w="3513805"/>
              </a:tblGrid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CL2146.Contig1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TAAAGTGAACCCACAAACTGG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ACTTGTCTAAACCTCGCATAA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CL8463.Contig2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CTAATCAGTGAGCAGGGTGG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TCATTGGCATGTTTGAGTAGGC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CL5949.Contig2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TGGTAATCTTAATGCAGCTGCTC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TCTTGAAGAATTGAAACACCAAG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CL3893.Contig3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CCCTTCGTGAGATTAAACTGC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GACAATGCTCCTCTGACAAACC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CL1034.contig2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GTAGGATTGCGATGCGGGTTAG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/>
                          <a:ea typeface="宋体"/>
                        </a:rPr>
                        <a:t>TATGTGCTTGGGAGGGATTTGC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CL9057.Contig1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TGCTATTACTGGTTTGGGAAGG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TTGCTGCGTTTACTGATGCTAG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CL4746.Contig1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GCTTCGTCACCTCCTTCCTCAC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AATGTATCTGCTGGTCCCTTG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Unigene9728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GACTATCCCGATGAGGACTGGC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TGAACAATGGACTCGCTGAAGG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宋体"/>
                        </a:rPr>
                        <a:t>CL2465.Contig5_All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CTCCAATAAATGAATCACCAGCAC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GCTTTGAAACTTTGGCGTCCTA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宋体"/>
                        </a:rPr>
                        <a:t>CL8598.contig2_Al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FW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ACTCCCTGTCTCCTTCTCAAAC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844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宋体"/>
                        </a:rPr>
                        <a:t> 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宋体"/>
                        </a:rPr>
                        <a:t>RV</a:t>
                      </a:r>
                      <a:endParaRPr lang="zh-CN" sz="1200" kern="10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/>
                          <a:ea typeface="宋体"/>
                        </a:rPr>
                        <a:t>ATCAGATGCTCATAGCCAACC</a:t>
                      </a:r>
                      <a:endParaRPr lang="zh-CN" sz="1200" kern="100" dirty="0">
                        <a:effectLst/>
                        <a:latin typeface="Times New Roman"/>
                        <a:ea typeface="宋体"/>
                      </a:endParaRPr>
                    </a:p>
                  </a:txBody>
                  <a:tcPr marL="68587" marR="6858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3626" name="Rectangle 3"/>
          <p:cNvSpPr>
            <a:spLocks noChangeArrowheads="1"/>
          </p:cNvSpPr>
          <p:nvPr/>
        </p:nvSpPr>
        <p:spPr bwMode="auto">
          <a:xfrm>
            <a:off x="539750" y="392113"/>
            <a:ext cx="4967288" cy="862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charset="-122"/>
                <a:sym typeface="Calibri" pitchFamily="34" charset="0"/>
              </a:defRPr>
            </a:lvl9pPr>
          </a:lstStyle>
          <a:p>
            <a:pPr>
              <a:spcBef>
                <a:spcPct val="0"/>
              </a:spcBef>
              <a:buFont typeface="Arial" charset="0"/>
              <a:buNone/>
            </a:pPr>
            <a:r>
              <a:rPr lang="en-US" altLang="zh-CN" sz="18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180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7.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-PCR </a:t>
            </a:r>
            <a:r>
              <a:rPr lang="en-US" altLang="zh-CN" sz="18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Primer</a:t>
            </a:r>
            <a:endParaRPr lang="zh-CN" altLang="en-US" sz="18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  <a:p>
            <a:pPr>
              <a:spcBef>
                <a:spcPct val="0"/>
              </a:spcBef>
              <a:buFont typeface="Arial" charset="0"/>
              <a:buNone/>
            </a:pPr>
            <a:r>
              <a:rPr lang="zh-CN" altLang="en-US" sz="1600" dirty="0">
                <a:latin typeface="Times New Roman" pitchFamily="18" charset="0"/>
                <a:cs typeface="Times New Roman" pitchFamily="18" charset="0"/>
              </a:rPr>
              <a:t> </a:t>
            </a:r>
          </a:p>
          <a:p>
            <a:pPr>
              <a:spcBef>
                <a:spcPct val="0"/>
              </a:spcBef>
              <a:buFontTx/>
              <a:buNone/>
            </a:pP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0962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3</Words>
  <Application>Microsoft Macintosh PowerPoint</Application>
  <PresentationFormat>On-screen Show (4:3)</PresentationFormat>
  <Paragraphs>6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ky123.O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</dc:creator>
  <cp:lastModifiedBy>L L</cp:lastModifiedBy>
  <cp:revision>2</cp:revision>
  <dcterms:created xsi:type="dcterms:W3CDTF">2014-10-16T03:00:42Z</dcterms:created>
  <dcterms:modified xsi:type="dcterms:W3CDTF">2015-05-28T04:38:52Z</dcterms:modified>
</cp:coreProperties>
</file>